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5080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41" d="100"/>
          <a:sy n="41" d="100"/>
        </p:scale>
        <p:origin x="2538" y="72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dreas Roos" userId="80ed2b38bc7399a1" providerId="LiveId" clId="{9E14D397-3FBA-436D-A803-10843B532961}"/>
    <pc:docChg chg="custSel modSld">
      <pc:chgData name="Andreas Roos" userId="80ed2b38bc7399a1" providerId="LiveId" clId="{9E14D397-3FBA-436D-A803-10843B532961}" dt="2018-05-31T18:44:14.728" v="9" actId="478"/>
      <pc:docMkLst>
        <pc:docMk/>
      </pc:docMkLst>
      <pc:sldChg chg="delSp modSp">
        <pc:chgData name="Andreas Roos" userId="80ed2b38bc7399a1" providerId="LiveId" clId="{9E14D397-3FBA-436D-A803-10843B532961}" dt="2018-05-31T18:44:14.728" v="9" actId="478"/>
        <pc:sldMkLst>
          <pc:docMk/>
          <pc:sldMk cId="1870074665" sldId="262"/>
        </pc:sldMkLst>
        <pc:spChg chg="del">
          <ac:chgData name="Andreas Roos" userId="80ed2b38bc7399a1" providerId="LiveId" clId="{9E14D397-3FBA-436D-A803-10843B532961}" dt="2018-05-31T18:44:14.728" v="9" actId="478"/>
          <ac:spMkLst>
            <pc:docMk/>
            <pc:sldMk cId="1870074665" sldId="262"/>
            <ac:spMk id="4" creationId="{00000000-0000-0000-0000-000000000000}"/>
          </ac:spMkLst>
        </pc:spChg>
        <pc:spChg chg="mod">
          <ac:chgData name="Andreas Roos" userId="80ed2b38bc7399a1" providerId="LiveId" clId="{9E14D397-3FBA-436D-A803-10843B532961}" dt="2018-05-31T18:44:10.407" v="8" actId="1037"/>
          <ac:spMkLst>
            <pc:docMk/>
            <pc:sldMk cId="1870074665" sldId="262"/>
            <ac:spMk id="7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31.05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6487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31.05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48506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31.05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3676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31.05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99396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31.05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629506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31.05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4497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31.05.2018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5379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31.05.2018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360561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31.05.2018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44727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31.05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2785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31.05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95154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432413-EBE5-4AB1-9A86-303CDA477925}" type="datetimeFigureOut">
              <a:rPr lang="de-DE" smtClean="0"/>
              <a:t>31.05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51118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denisa.hathazi\Desktop\cav3_after RZ\localization up[Converted]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26" y="1735927"/>
            <a:ext cx="6203852" cy="15232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3" descr="C:\Users\denisa.hathazi\Desktop\cav3_after RZ\down subcel [Converted]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0927" y="3963062"/>
            <a:ext cx="6107073" cy="13799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feld 4"/>
          <p:cNvSpPr txBox="1"/>
          <p:nvPr/>
        </p:nvSpPr>
        <p:spPr>
          <a:xfrm>
            <a:off x="155497" y="3391716"/>
            <a:ext cx="6034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800" b="1" dirty="0"/>
              <a:t>B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153149" y="1110409"/>
            <a:ext cx="6034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800" b="1" dirty="0"/>
              <a:t>A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274315" y="140628"/>
            <a:ext cx="644300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Subcellular</a:t>
            </a:r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localization</a:t>
            </a:r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proteins</a:t>
            </a:r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altered</a:t>
            </a:r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abundance</a:t>
            </a:r>
            <a:endParaRPr lang="de-DE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1"/>
          <p:cNvSpPr txBox="1"/>
          <p:nvPr/>
        </p:nvSpPr>
        <p:spPr>
          <a:xfrm>
            <a:off x="2426049" y="1144261"/>
            <a:ext cx="19195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ncreased proteins</a:t>
            </a:r>
          </a:p>
        </p:txBody>
      </p:sp>
      <p:sp>
        <p:nvSpPr>
          <p:cNvPr id="9" name="TextBox 1"/>
          <p:cNvSpPr txBox="1"/>
          <p:nvPr/>
        </p:nvSpPr>
        <p:spPr>
          <a:xfrm>
            <a:off x="2423701" y="3449017"/>
            <a:ext cx="1998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ecreased proteins</a:t>
            </a:r>
          </a:p>
        </p:txBody>
      </p:sp>
    </p:spTree>
    <p:extLst>
      <p:ext uri="{BB962C8B-B14F-4D97-AF65-F5344CB8AC3E}">
        <p14:creationId xmlns:p14="http://schemas.microsoft.com/office/powerpoint/2010/main" val="18700746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</Words>
  <Application>Microsoft Office PowerPoint</Application>
  <PresentationFormat>Breitbild</PresentationFormat>
  <Paragraphs>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ndreas Roos</dc:creator>
  <cp:lastModifiedBy>Andreas Roos</cp:lastModifiedBy>
  <cp:revision>138</cp:revision>
  <dcterms:created xsi:type="dcterms:W3CDTF">2016-02-20T23:50:36Z</dcterms:created>
  <dcterms:modified xsi:type="dcterms:W3CDTF">2018-05-31T18:44:16Z</dcterms:modified>
</cp:coreProperties>
</file>